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9" d="100"/>
          <a:sy n="119" d="100"/>
        </p:scale>
        <p:origin x="1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AB46BB-098C-4CE8-A888-98196E981A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C853BEC-7A1E-4D00-AEF8-BD6179068B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E7BA748-D679-4FE1-8852-977C63B83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F2373BB-A9E0-49A4-88EF-3B864F280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84134F8-6642-4254-8387-E8875C9BD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7098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26CEDE-3419-4189-8A42-611A7F27AB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4728A59-2708-41C6-A1FD-0650897B00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820CC7D-4655-4297-870A-5B072F7BB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260CC44-C0BB-4578-81BC-8FE778E9D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5CF4FEF-D3FE-451F-A9FB-49699543D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8280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AE5695D-EA83-4219-B6C0-3B6F096640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BF653B4-078F-4B67-B173-8C2A5D18D8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D1C6520-31B7-44EA-BEF6-08DB2996E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E1DABE5-75E3-4811-B047-4C2FDA963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9EE2366-2591-466D-A0C1-4B07D4805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5370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89BD88-B9AB-4CF3-9997-9838E6EDE7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4A55B55-0FFC-4AEE-942A-363892D762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46A281C-2959-45B2-B4F3-1DD1C3AD8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96EA21E-55BC-4D05-9E92-8E3AF1B1C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7716705-25EE-4693-B375-C66A1A867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8196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D0EE39-5407-4AA1-AB5A-39E0F53CB5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288E2C4-C98B-49DE-9645-A979931C47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B606620-909C-4644-AF71-30B033662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0C0A4D-67D4-4EEC-BED3-0702AC7A6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CEF900-88BA-4CD8-8B36-AF4C72EE1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6412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8441CE-AD6D-40C7-BDB4-9E8607ED1C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C3749FE-DB93-4F64-881F-C81C1436B6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D9E2A60-FB15-4FD3-8996-B975D75F31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71E7857-F557-4F9C-97E9-A57C9F667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EDE64E5-591E-431F-962B-CBEB3DF53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835FD60-AA77-4F84-9F7B-3FAC00E38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7726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F9310A-E26B-4FF7-B3F6-AF914FFFE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6457D8E-5E61-45F7-AD22-7412049726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E55DC89-C8D9-4492-B963-927175CA62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2E2150A4-E783-4CEA-9C9D-0D231BDAC0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8583314-281C-4CF2-899C-DC90DE76D7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ABCF5C3-D13F-4B78-A5C1-033F180FC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42DD1AE-8BBC-4318-9B53-7A5C410C1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6EFF346-D50D-451B-8230-834CE1281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8638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9C1D221-EDD9-4F28-B759-727214E47D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6A20977-CBAF-420E-9B0A-6C7730471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7B187AD-ED63-4790-9B2F-050FC2DC0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409B9C4-6334-48C0-AA34-29B286BE6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9435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FBFF0D5-32AF-4531-B1CD-E0DF1033C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5082C73-EA29-4486-9B0C-C4B34DF8E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F6A637A1-CC60-4DCA-ACE6-77EFD7B0F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6501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9D222D-16D3-4527-A352-FD8067F560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905EFC6-7111-43FE-9CEB-606CF67D88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8D26E73-E1E8-44B1-8957-87BF3DD5F5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57C1031-66E9-486B-89D4-16640B427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62E40AE-B31B-4223-A6BC-73CF3276C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B13CDD9-71BB-4D6A-8219-27B54419C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9447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1F8CE5B-70BC-446B-B698-80CB6E1354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5966E47-BF6E-4A6E-8FC9-A25AC31E71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20D695C-4886-426F-8F20-DC36AEA519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1C13216-3A30-4AAA-97A0-63EF0A022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551C3C1-6C0B-459B-9259-EBF7DB89A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6164ABD-383B-4982-A321-E6A83DF33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323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0ED81FE-F3CF-4501-9BCE-646B29955E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6308CDE-AE88-4369-8B2D-E455C80CAB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8E8B90B-FEA3-4B0B-A971-FC7420EC63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ABF8C-8DE3-4DBC-86C4-BB4E082BFC1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CDDCF0B-67A7-419E-B5F6-EC7DD1C93C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F25C533-3F3E-4D23-8FEA-61D25F5E8B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2E127-AB10-4786-B0B6-28AC764AAD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4016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D173446-6230-45CB-AEB0-DED0AF91772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508" b="30947"/>
          <a:stretch/>
        </p:blipFill>
        <p:spPr>
          <a:xfrm rot="16200000">
            <a:off x="417336" y="896010"/>
            <a:ext cx="5075399" cy="423367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446DFDD-ED3D-4A94-85E8-7AB62C7E328A}"/>
              </a:ext>
            </a:extLst>
          </p:cNvPr>
          <p:cNvSpPr txBox="1"/>
          <p:nvPr/>
        </p:nvSpPr>
        <p:spPr>
          <a:xfrm>
            <a:off x="2298192" y="5730240"/>
            <a:ext cx="4529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Fig. S2C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C1439BA-D6F5-4E1E-9432-7E3A637F307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445" b="34044"/>
          <a:stretch/>
        </p:blipFill>
        <p:spPr>
          <a:xfrm rot="16200000">
            <a:off x="5847409" y="943254"/>
            <a:ext cx="4965550" cy="4139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97884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3A1761F1-20F8-4D8B-9906-78A2A8E548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6030119"/>
            <a:ext cx="9144000" cy="1655762"/>
          </a:xfrm>
        </p:spPr>
        <p:txBody>
          <a:bodyPr/>
          <a:lstStyle/>
          <a:p>
            <a:r>
              <a:rPr lang="en-US" dirty="0"/>
              <a:t>pH=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EA16545-9AE3-48A7-91AF-1AE05EFB4FF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308" t="28311" r="8308" b="35022"/>
          <a:stretch/>
        </p:blipFill>
        <p:spPr>
          <a:xfrm rot="16200000">
            <a:off x="6130082" y="1322278"/>
            <a:ext cx="4503836" cy="366979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4D7C815-659E-4D19-929D-7CD46132E6F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733" b="32267"/>
          <a:stretch/>
        </p:blipFill>
        <p:spPr>
          <a:xfrm rot="16200000">
            <a:off x="848868" y="1104900"/>
            <a:ext cx="4264152" cy="3864864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6AD9F7A9-E9C2-422B-8003-B4B0A1B9BB04}"/>
              </a:ext>
            </a:extLst>
          </p:cNvPr>
          <p:cNvSpPr txBox="1"/>
          <p:nvPr/>
        </p:nvSpPr>
        <p:spPr>
          <a:xfrm>
            <a:off x="802256" y="40544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6B</a:t>
            </a:r>
          </a:p>
        </p:txBody>
      </p:sp>
    </p:spTree>
    <p:extLst>
      <p:ext uri="{BB962C8B-B14F-4D97-AF65-F5344CB8AC3E}">
        <p14:creationId xmlns:p14="http://schemas.microsoft.com/office/powerpoint/2010/main" val="3734380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4E18645D-42F1-457D-8D6E-29163E970D3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024" b="27024"/>
          <a:stretch/>
        </p:blipFill>
        <p:spPr>
          <a:xfrm rot="16200000">
            <a:off x="6929633" y="509317"/>
            <a:ext cx="4087370" cy="4779268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63CD118-6B99-453D-ABE8-D661E8311811}"/>
              </a:ext>
            </a:extLst>
          </p:cNvPr>
          <p:cNvSpPr txBox="1"/>
          <p:nvPr/>
        </p:nvSpPr>
        <p:spPr>
          <a:xfrm>
            <a:off x="5266944" y="5888736"/>
            <a:ext cx="3669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H=5.5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17CDE3C-9DA1-42F5-B006-30454D7C9E1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01" r="23599"/>
          <a:stretch/>
        </p:blipFill>
        <p:spPr>
          <a:xfrm>
            <a:off x="694938" y="868831"/>
            <a:ext cx="5157216" cy="4087368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B87318FF-A449-4B82-9280-CAE540BE0840}"/>
              </a:ext>
            </a:extLst>
          </p:cNvPr>
          <p:cNvSpPr txBox="1"/>
          <p:nvPr/>
        </p:nvSpPr>
        <p:spPr>
          <a:xfrm>
            <a:off x="694938" y="258792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6B</a:t>
            </a:r>
          </a:p>
        </p:txBody>
      </p:sp>
    </p:spTree>
    <p:extLst>
      <p:ext uri="{BB962C8B-B14F-4D97-AF65-F5344CB8AC3E}">
        <p14:creationId xmlns:p14="http://schemas.microsoft.com/office/powerpoint/2010/main" val="41999162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1820E422-A428-4F37-B9A3-5082E4C327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92352" y="5369878"/>
            <a:ext cx="9144000" cy="1225994"/>
          </a:xfrm>
        </p:spPr>
        <p:txBody>
          <a:bodyPr/>
          <a:lstStyle/>
          <a:p>
            <a:r>
              <a:rPr lang="en-US" dirty="0"/>
              <a:t>pH=4.5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8B338A7-5EFC-4F54-872A-390EAB7DA2D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00" r="34300"/>
          <a:stretch/>
        </p:blipFill>
        <p:spPr>
          <a:xfrm>
            <a:off x="4091052" y="262128"/>
            <a:ext cx="3546600" cy="367893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24603B2-D5A4-4682-A9F7-C311DA57793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0" r="32000"/>
          <a:stretch/>
        </p:blipFill>
        <p:spPr>
          <a:xfrm>
            <a:off x="195072" y="262128"/>
            <a:ext cx="3890673" cy="360615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946D601-C47B-4ED2-9494-43E50936FFF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578" b="31911"/>
          <a:stretch/>
        </p:blipFill>
        <p:spPr>
          <a:xfrm rot="16200000">
            <a:off x="7924140" y="141046"/>
            <a:ext cx="3648511" cy="3890674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77EBC8FF-2AD9-48AB-9FD2-ACF792FD5F69}"/>
              </a:ext>
            </a:extLst>
          </p:cNvPr>
          <p:cNvSpPr txBox="1"/>
          <p:nvPr/>
        </p:nvSpPr>
        <p:spPr>
          <a:xfrm>
            <a:off x="802256" y="40544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6B</a:t>
            </a:r>
          </a:p>
        </p:txBody>
      </p:sp>
    </p:spTree>
    <p:extLst>
      <p:ext uri="{BB962C8B-B14F-4D97-AF65-F5344CB8AC3E}">
        <p14:creationId xmlns:p14="http://schemas.microsoft.com/office/powerpoint/2010/main" val="12686703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161D1F4C-AC32-4273-BF0E-7CC2635F42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5101654"/>
            <a:ext cx="9144000" cy="1655762"/>
          </a:xfrm>
        </p:spPr>
        <p:txBody>
          <a:bodyPr/>
          <a:lstStyle/>
          <a:p>
            <a:r>
              <a:rPr lang="en-US" dirty="0"/>
              <a:t>pH=3.5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D8CA6C6-9BD6-41BE-8D52-A25D69B252B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7" t="30756" r="16952" b="34222"/>
          <a:stretch/>
        </p:blipFill>
        <p:spPr>
          <a:xfrm rot="16200000">
            <a:off x="5800343" y="606551"/>
            <a:ext cx="3901441" cy="41757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D07521F-BE06-447B-B820-F16EF635FDA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022" b="25610"/>
          <a:stretch/>
        </p:blipFill>
        <p:spPr>
          <a:xfrm rot="16200000">
            <a:off x="680351" y="641076"/>
            <a:ext cx="3901442" cy="4106710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E151DE05-96B6-4025-9E58-EA7614DD7220}"/>
              </a:ext>
            </a:extLst>
          </p:cNvPr>
          <p:cNvSpPr txBox="1"/>
          <p:nvPr/>
        </p:nvSpPr>
        <p:spPr>
          <a:xfrm>
            <a:off x="802256" y="40544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6B</a:t>
            </a:r>
          </a:p>
        </p:txBody>
      </p:sp>
    </p:spTree>
    <p:extLst>
      <p:ext uri="{BB962C8B-B14F-4D97-AF65-F5344CB8AC3E}">
        <p14:creationId xmlns:p14="http://schemas.microsoft.com/office/powerpoint/2010/main" val="11068916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5DDAE58B-0C18-443D-89F2-AE15F077F8E9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3294434" y="734438"/>
            <a:ext cx="5603132" cy="5389123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04A361D8-B7E8-4430-BDD9-4C2228F56266}"/>
              </a:ext>
            </a:extLst>
          </p:cNvPr>
          <p:cNvSpPr txBox="1"/>
          <p:nvPr/>
        </p:nvSpPr>
        <p:spPr>
          <a:xfrm>
            <a:off x="802256" y="40544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6B</a:t>
            </a:r>
          </a:p>
        </p:txBody>
      </p:sp>
    </p:spTree>
    <p:extLst>
      <p:ext uri="{BB962C8B-B14F-4D97-AF65-F5344CB8AC3E}">
        <p14:creationId xmlns:p14="http://schemas.microsoft.com/office/powerpoint/2010/main" val="1698184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64675650-A50C-47B4-8D86-E7E632863F7E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3294434" y="739302"/>
            <a:ext cx="5603132" cy="5379396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91E74B68-2F74-4549-AC3B-4BD4B81389E8}"/>
              </a:ext>
            </a:extLst>
          </p:cNvPr>
          <p:cNvSpPr txBox="1"/>
          <p:nvPr/>
        </p:nvSpPr>
        <p:spPr>
          <a:xfrm>
            <a:off x="802256" y="40544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6B</a:t>
            </a:r>
          </a:p>
        </p:txBody>
      </p:sp>
    </p:spTree>
    <p:extLst>
      <p:ext uri="{BB962C8B-B14F-4D97-AF65-F5344CB8AC3E}">
        <p14:creationId xmlns:p14="http://schemas.microsoft.com/office/powerpoint/2010/main" val="4345802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A12DE34A-1111-43C3-9014-AA26446B082B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3294434" y="992221"/>
            <a:ext cx="5603132" cy="4873557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AE93EDC2-B199-4A9D-97D8-984C9D4BC0E8}"/>
              </a:ext>
            </a:extLst>
          </p:cNvPr>
          <p:cNvSpPr txBox="1"/>
          <p:nvPr/>
        </p:nvSpPr>
        <p:spPr>
          <a:xfrm>
            <a:off x="802256" y="40544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6B</a:t>
            </a:r>
          </a:p>
        </p:txBody>
      </p:sp>
    </p:spTree>
    <p:extLst>
      <p:ext uri="{BB962C8B-B14F-4D97-AF65-F5344CB8AC3E}">
        <p14:creationId xmlns:p14="http://schemas.microsoft.com/office/powerpoint/2010/main" val="9527785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Breitbild</PresentationFormat>
  <Paragraphs>12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erg Koch</dc:creator>
  <cp:lastModifiedBy>Joerg Koch</cp:lastModifiedBy>
  <cp:revision>3</cp:revision>
  <dcterms:created xsi:type="dcterms:W3CDTF">2025-11-01T14:05:06Z</dcterms:created>
  <dcterms:modified xsi:type="dcterms:W3CDTF">2025-11-01T14:13:33Z</dcterms:modified>
</cp:coreProperties>
</file>